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2" r:id="rId2"/>
    <p:sldId id="263" r:id="rId3"/>
    <p:sldId id="264" r:id="rId4"/>
    <p:sldId id="265" r:id="rId5"/>
    <p:sldId id="266" r:id="rId6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20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557"/>
    <p:restoredTop sz="96340"/>
  </p:normalViewPr>
  <p:slideViewPr>
    <p:cSldViewPr snapToGrid="0" snapToObjects="1">
      <p:cViewPr varScale="1">
        <p:scale>
          <a:sx n="136" d="100"/>
          <a:sy n="136" d="100"/>
        </p:scale>
        <p:origin x="2328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280287-4910-2540-BA77-95FCFFA32277}" type="datetimeFigureOut">
              <a:rPr lang="es-ES" smtClean="0"/>
              <a:t>1/10/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18CCE5-AEB2-364F-A693-573E30E3363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51080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D2FDE4-E479-9C4C-9C46-D08A38CB6F57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44861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D2FDE4-E479-9C4C-9C46-D08A38CB6F57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213898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D2FDE4-E479-9C4C-9C46-D08A38CB6F57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61530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D2FDE4-E479-9C4C-9C46-D08A38CB6F57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048848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D2FDE4-E479-9C4C-9C46-D08A38CB6F57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51966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C3B5F27-AA5F-E74C-AE68-F9A47E3163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0D29E77-135E-CD4F-A1F4-BA31AAD031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DFB4B65-B837-7446-B3CC-A61E94C93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38CD87D-9D7B-CE4A-8BF1-CA68255B5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2AAC186-91C3-3A4D-9C8F-4569F2E20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8421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0FDDF8-C2F3-7C4E-A911-CAAC935E5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44D6E7E-E961-9242-BB40-B207E5EE28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001ECE0-4C2E-7947-8FA2-04315A96E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415C116-0C80-CD44-9AB4-5F4112360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F940BA0-061E-FA4D-81CC-98B05C1CB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431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F112077-F1D3-4641-B7A1-22EE405E32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A721860-1238-5644-B27D-FBBCFA9150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A7FDE39-EFA7-E84D-9F18-21EFE4B19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A580117-A7EA-8649-AD92-9F4982905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252243B-3872-9448-BD6E-02BBF1648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838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2E875B-276C-2F42-9517-0A6A4934EB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B751AE9-41A6-464D-B14A-E6A6944109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7A0E2A5-E293-A84B-AD47-7768FF526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AFCF6AE-DC2D-9043-A51B-062951643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97451F8-11E8-6942-ADC6-76E6B1F0D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2901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DFF8E48-2E91-6F42-9771-5F90DA21FC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E92B439-ACAB-0C41-8576-ACD4F6D973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E898FAB-FFF5-0943-AED6-AFE7B40E58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F7E97D3-CA46-4742-A1B0-9E47E84EA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4A716B8-D03F-034B-BFA2-D76F3E898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6037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53D33D0-8D9B-5644-BB10-361A6617A7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5BC3483-1E67-C645-80B1-294AD0515E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9053A67-ECE6-1142-9FC2-99619412AE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1C5CE4C-5A01-6F4B-BF97-6F9A2AF4C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A2EDD42-0AFE-D047-9797-16A25097A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0250E3B-FD32-AD4C-8634-5EEF51720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0081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3BD05D-7A18-0F45-B2D1-6BD077843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6BB9A6B-1722-7D4D-86C7-D152A4FD77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3966539-790D-9940-90F1-AFA8A0F863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9284D5E-3B6D-D143-8C01-1EECA06997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1904DAA-9221-684C-8735-7699B72DD8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A2A1AF0D-691B-2D45-90C8-D769FF659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9C68BE6E-429C-9B43-9C7C-EB4416994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2D71835-A5FB-8349-A074-119BD73CB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5039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5DFA8A-7BF1-8449-9371-F745873987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E0EF192-783D-8743-977B-10074EC26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8063605-28F6-DA43-B41B-3AE2531F9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6BC0B2E7-5F16-9D4B-94A5-A5D43C2DA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5476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DBD1CB7A-E4D9-2947-8493-FB11F2E20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A1B40C4F-CE64-0747-9E50-A6A9E8B2F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E0675A5-E2BB-1444-8AAC-03AEC6079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907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9ABF203-5DB9-704A-8C55-ED7D2F0B29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6BB70DC-0D3D-9D42-9B48-F994F3ECA2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8614A57-4776-334F-A76E-E82B963AA5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FF61C99-4932-A644-8FC9-A16B7EB2A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7F8D642-AAEC-854E-80C2-284CA73AB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5661CD0-29C1-CB41-AB21-D5F8577C1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5858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F3A44F7-2D95-BD44-905C-F9543C712A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F881E471-47E1-8843-ADB7-DE676EAEDF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82E4E74-19DD-1548-B64A-B50F76D01A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307FC1F-1F31-644E-9CEF-1B8BB9842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0E4173E-A455-5C47-BC84-1F9C9A5CFD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0413AC1-212D-E64D-9757-98257C057D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1237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649CBB1-2E5D-4D46-AB8E-ABCF85448D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FEE6FC4-A114-C648-BBE3-16EF80E28E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F9FF4BF-0382-894C-AF5A-5BC0A52398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540037-2911-9346-8C4C-EBC2AA61044F}" type="datetimeFigureOut">
              <a:rPr lang="es-ES" smtClean="0"/>
              <a:t>1/10/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A903957-8178-CB44-92BF-AD53F057AE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AA61AF0-1BAF-E44E-8FC8-8C8229714A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ABD664-11E5-5A43-8349-51379F40E8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8412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440628F-9810-2C4D-AE64-DB3B1DD15FC5}"/>
              </a:ext>
            </a:extLst>
          </p:cNvPr>
          <p:cNvSpPr txBox="1"/>
          <p:nvPr/>
        </p:nvSpPr>
        <p:spPr>
          <a:xfrm>
            <a:off x="493799" y="349290"/>
            <a:ext cx="584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Supplementary </a:t>
            </a:r>
            <a:r>
              <a:rPr lang="en-GB" sz="1200" b="1">
                <a:latin typeface="Times New Roman" charset="0"/>
                <a:ea typeface="Times New Roman" charset="0"/>
                <a:cs typeface="Times New Roman" charset="0"/>
              </a:rPr>
              <a:t>Table 1</a:t>
            </a:r>
            <a:r>
              <a:rPr lang="en-GB" sz="120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List of coincident genera comparing all the six possible media.</a:t>
            </a:r>
          </a:p>
        </p:txBody>
      </p:sp>
      <p:sp>
        <p:nvSpPr>
          <p:cNvPr id="18" name="Rectangle 57"/>
          <p:cNvSpPr>
            <a:spLocks noChangeArrowheads="1"/>
          </p:cNvSpPr>
          <p:nvPr/>
        </p:nvSpPr>
        <p:spPr bwMode="auto">
          <a:xfrm>
            <a:off x="493799" y="-4346029"/>
            <a:ext cx="2677892" cy="214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4853478"/>
              </p:ext>
            </p:extLst>
          </p:nvPr>
        </p:nvGraphicFramePr>
        <p:xfrm>
          <a:off x="606226" y="753622"/>
          <a:ext cx="5729573" cy="73331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3049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146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48444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94155"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RA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X; TSA 0.1X; TSA 0.01X;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; R2A 0.1X; R2A 0.0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obacter,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omoserinibacter,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bacterium,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identified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X; TSA 0.1X; TSA 0.01X;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; R2A 0.0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curi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X; TSA 0.1X; TSA 0.01X;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0.1X; R2A 0.0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neococcu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X; TSA 0.01X</a:t>
                      </a:r>
                    </a:p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; R2A 0.1X; R2A 0.0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olici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X; TSA 0.1X; TSA 0.01X;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tzea,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phingomonas, Roseomonas, Belnapia, Ramli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X; TSA 0.1X</a:t>
                      </a:r>
                    </a:p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; R2A 0.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ermanell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X; TSA 0.01X;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stobacter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 0.1X; TSA 0.01X</a:t>
                      </a:r>
                    </a:p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; R2A 0.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eptomyce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 0.1X;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; R2A 0.0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o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X; TSA 0.01X</a:t>
                      </a:r>
                      <a:endParaRPr lang="en-GB" sz="1000" baseline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nctomona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 0.1X; TSA 0.01X</a:t>
                      </a:r>
                      <a:endParaRPr lang="en-GB" sz="1000" baseline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virg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 0.1X;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cardioides,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eodermatophilus, Umezawae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 0.01X;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ibbella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39185">
                <a:tc>
                  <a:txBody>
                    <a:bodyPr/>
                    <a:lstStyle/>
                    <a:p>
                      <a:pPr algn="l"/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 0.01X; </a:t>
                      </a: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0.0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oplanes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; R2A 0.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sili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X</a:t>
                      </a:r>
                      <a:endParaRPr lang="en-GB" sz="1000" baseline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coccus, Staphylococcu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 0.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ovorax,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oviherbaspirillum, Paenarthrobacter, Amycolatopsi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algn="l"/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A 0.01X</a:t>
                      </a:r>
                      <a:endParaRPr lang="en-GB" sz="1000" baseline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terovirga, New genus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rococcus, Blastococcus, Caulobacter, Azospirill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0.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baspirillum,</a:t>
                      </a:r>
                      <a:r>
                        <a:rPr lang="en-GB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acillu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94155">
                <a:tc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A 0.01X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aviflagelli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45557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440628F-9810-2C4D-AE64-DB3B1DD15FC5}"/>
              </a:ext>
            </a:extLst>
          </p:cNvPr>
          <p:cNvSpPr txBox="1"/>
          <p:nvPr/>
        </p:nvSpPr>
        <p:spPr>
          <a:xfrm>
            <a:off x="493799" y="349290"/>
            <a:ext cx="584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Supplementary Table 2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. List of genera in each biocrust sample in geolocation 1. NID means ‘Not identified’. Abundance is expressed as the absolute number of strains isolated in pure culture.</a:t>
            </a:r>
          </a:p>
        </p:txBody>
      </p:sp>
      <p:sp>
        <p:nvSpPr>
          <p:cNvPr id="18" name="Rectangle 57"/>
          <p:cNvSpPr>
            <a:spLocks noChangeArrowheads="1"/>
          </p:cNvSpPr>
          <p:nvPr/>
        </p:nvSpPr>
        <p:spPr bwMode="auto">
          <a:xfrm>
            <a:off x="493799" y="-4346029"/>
            <a:ext cx="2677892" cy="214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5187864"/>
              </p:ext>
            </p:extLst>
          </p:nvPr>
        </p:nvGraphicFramePr>
        <p:xfrm>
          <a:off x="645555" y="995621"/>
          <a:ext cx="5773210" cy="8534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959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51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894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02635">
                  <a:extLst>
                    <a:ext uri="{9D8B030D-6E8A-4147-A177-3AD203B41FA5}">
                      <a16:colId xmlns:a16="http://schemas.microsoft.com/office/drawing/2014/main" val="1471214758"/>
                    </a:ext>
                  </a:extLst>
                </a:gridCol>
              </a:tblGrid>
              <a:tr h="243807"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location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RA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undance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3807">
                <a:tc rowSpan="34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7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.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o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curi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D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cardioide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neococcu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Roseomona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4990062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virg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lnapi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o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890355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W GENUS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dermatophilu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narthro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nctomona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Homoserini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290040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Streptomyc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7603598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odesto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680794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Blastococc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058630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.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o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dermatophilu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olici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mli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Blastococc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1695138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rococcu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ingomona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ermanell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neococcu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eptomyce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curi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3857571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ibbell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7466063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.3.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Skermanell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24236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Sphingomona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461368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Arthro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064800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Planctomona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9199318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ycolicibacterium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98701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92750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57"/>
          <p:cNvSpPr>
            <a:spLocks noChangeArrowheads="1"/>
          </p:cNvSpPr>
          <p:nvPr/>
        </p:nvSpPr>
        <p:spPr bwMode="auto">
          <a:xfrm>
            <a:off x="493799" y="-4346029"/>
            <a:ext cx="2677892" cy="214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0423352"/>
              </p:ext>
            </p:extLst>
          </p:nvPr>
        </p:nvGraphicFramePr>
        <p:xfrm>
          <a:off x="572457" y="388173"/>
          <a:ext cx="5773210" cy="9190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959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51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894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02635">
                  <a:extLst>
                    <a:ext uri="{9D8B030D-6E8A-4147-A177-3AD203B41FA5}">
                      <a16:colId xmlns:a16="http://schemas.microsoft.com/office/drawing/2014/main" val="1471214758"/>
                    </a:ext>
                  </a:extLst>
                </a:gridCol>
              </a:tblGrid>
              <a:tr h="248400"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location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RA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undance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8400">
                <a:tc rowSpan="36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.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Lentze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7723247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Kocuri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6271672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Variovora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6490553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Homoserini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2772784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NI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938910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Belnapi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4332307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Herbaspirillum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9579914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sili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Kineococc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icrovirg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Blastococc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Enterovirg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4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.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Arthro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Homoserini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Kineococc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l"/>
                      <a:endParaRPr lang="en-GB" sz="1000" baseline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NI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Lentze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l"/>
                      <a:endParaRPr lang="en-GB" sz="1000" baseline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ycolicibacterium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Nocardioid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Planctomona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Sphingomona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ethylobacterium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3857571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icrobacterium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7466063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Streptomyc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0786590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assili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9973885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Roseomona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9135132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Flaviflagelli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0983858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odesto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4555412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Skermanell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8902220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Amycolatops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070220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Staphylococc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4792918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Belnapi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6765187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Actinoplan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7419269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Kocuri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8640036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Caulo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7301369"/>
                  </a:ext>
                </a:extLst>
              </a:tr>
              <a:tr h="248400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Azospirillum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598088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927098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440628F-9810-2C4D-AE64-DB3B1DD15FC5}"/>
              </a:ext>
            </a:extLst>
          </p:cNvPr>
          <p:cNvSpPr txBox="1"/>
          <p:nvPr/>
        </p:nvSpPr>
        <p:spPr>
          <a:xfrm>
            <a:off x="493799" y="349290"/>
            <a:ext cx="584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Supplementary Table 3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. List of genera in each biocrust sample in geolocation 1. NID means ‘Not identified’. Abundance is expressed as the absolute number of strains isolated in pure culture.</a:t>
            </a:r>
          </a:p>
        </p:txBody>
      </p:sp>
      <p:sp>
        <p:nvSpPr>
          <p:cNvPr id="18" name="Rectangle 57"/>
          <p:cNvSpPr>
            <a:spLocks noChangeArrowheads="1"/>
          </p:cNvSpPr>
          <p:nvPr/>
        </p:nvSpPr>
        <p:spPr bwMode="auto">
          <a:xfrm>
            <a:off x="493799" y="-4346029"/>
            <a:ext cx="2677892" cy="214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4893921"/>
              </p:ext>
            </p:extLst>
          </p:nvPr>
        </p:nvGraphicFramePr>
        <p:xfrm>
          <a:off x="645554" y="995621"/>
          <a:ext cx="5773210" cy="5608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959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51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894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02635">
                  <a:extLst>
                    <a:ext uri="{9D8B030D-6E8A-4147-A177-3AD203B41FA5}">
                      <a16:colId xmlns:a16="http://schemas.microsoft.com/office/drawing/2014/main" val="1471214758"/>
                    </a:ext>
                  </a:extLst>
                </a:gridCol>
              </a:tblGrid>
              <a:tr h="243807"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location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RA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undance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3807">
                <a:tc rowSpan="2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4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.1.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o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lnapi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seomona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D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tze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ezawae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ingomona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sili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icrobacterium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152433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Blastococc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637606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olici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nctomona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o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8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.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eptomyce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Kocuri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2524077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Blastococc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6267163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ermanell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ingomona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o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ibbell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odesto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542145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440628F-9810-2C4D-AE64-DB3B1DD15FC5}"/>
              </a:ext>
            </a:extLst>
          </p:cNvPr>
          <p:cNvSpPr txBox="1"/>
          <p:nvPr/>
        </p:nvSpPr>
        <p:spPr>
          <a:xfrm>
            <a:off x="493799" y="349290"/>
            <a:ext cx="584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Supplementary Table 4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. List of genera in each biocrust sample in geolocation 1. NID means ‘Not identified’. Abundance is expressed as the absolute number of strains isolated in pure culture.</a:t>
            </a:r>
          </a:p>
        </p:txBody>
      </p:sp>
      <p:sp>
        <p:nvSpPr>
          <p:cNvPr id="18" name="Rectangle 57"/>
          <p:cNvSpPr>
            <a:spLocks noChangeArrowheads="1"/>
          </p:cNvSpPr>
          <p:nvPr/>
        </p:nvSpPr>
        <p:spPr bwMode="auto">
          <a:xfrm>
            <a:off x="493799" y="-4346029"/>
            <a:ext cx="2677892" cy="214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9729902"/>
              </p:ext>
            </p:extLst>
          </p:nvPr>
        </p:nvGraphicFramePr>
        <p:xfrm>
          <a:off x="645554" y="995621"/>
          <a:ext cx="5773210" cy="5608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959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51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894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02635">
                  <a:extLst>
                    <a:ext uri="{9D8B030D-6E8A-4147-A177-3AD203B41FA5}">
                      <a16:colId xmlns:a16="http://schemas.microsoft.com/office/drawing/2014/main" val="1471214758"/>
                    </a:ext>
                  </a:extLst>
                </a:gridCol>
              </a:tblGrid>
              <a:tr h="243807"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location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RA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undance</a:t>
                      </a:r>
                      <a:endParaRPr lang="en-GB" sz="1000" b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3807">
                <a:tc rowSpan="2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8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8.1.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o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D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seomonas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viherbaspirill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lnapi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ibbella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sto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985595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4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.1</a:t>
                      </a:r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olicibacterium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marL="0" marR="0" indent="0" algn="l" defTabSz="1320759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mli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D</a:t>
                      </a:r>
                      <a:endParaRPr lang="en-GB" sz="1000" i="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obacter</a:t>
                      </a:r>
                      <a:endParaRPr lang="en-GB" sz="1000" i="1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l"/>
                      <a:endParaRPr lang="en-GB" sz="1200" baseline="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GB" sz="12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Roseomona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Nocardioid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6102373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Kocuri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128287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Sphingomona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081329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Belnapi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087381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Skermanell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195892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icrococc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533286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Actinoplan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3356349"/>
                  </a:ext>
                </a:extLst>
              </a:tr>
              <a:tr h="243807"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000" dirty="0"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Modestobac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i="0" dirty="0"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3378800"/>
                  </a:ext>
                </a:extLst>
              </a:tr>
            </a:tbl>
          </a:graphicData>
        </a:graphic>
      </p:graphicFrame>
      <p:sp>
        <p:nvSpPr>
          <p:cNvPr id="5" name="CuadroTexto 1">
            <a:extLst>
              <a:ext uri="{FF2B5EF4-FFF2-40B4-BE49-F238E27FC236}">
                <a16:creationId xmlns:a16="http://schemas.microsoft.com/office/drawing/2014/main" id="{7F7137D0-1B88-B646-B5A4-9981C22D3BE8}"/>
              </a:ext>
            </a:extLst>
          </p:cNvPr>
          <p:cNvSpPr txBox="1"/>
          <p:nvPr/>
        </p:nvSpPr>
        <p:spPr>
          <a:xfrm>
            <a:off x="493799" y="7449244"/>
            <a:ext cx="584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Supplementary Table 5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. NCBI Blast results. The 16S rRNA sequences of the isolates were blasted against the NCBI ‘non-redundant nucleotide collection’ database optimised for highly similar sequences. The isolates that were not identified through molecular tools are classified as ‘Not identified’. ‘NA’ means ‘Not Available’.</a:t>
            </a:r>
          </a:p>
        </p:txBody>
      </p:sp>
    </p:spTree>
    <p:extLst>
      <p:ext uri="{BB962C8B-B14F-4D97-AF65-F5344CB8AC3E}">
        <p14:creationId xmlns:p14="http://schemas.microsoft.com/office/powerpoint/2010/main" val="1196966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08</TotalTime>
  <Words>670</Words>
  <Application>Microsoft Macintosh PowerPoint</Application>
  <PresentationFormat>A4 Paper (210x297 mm)</PresentationFormat>
  <Paragraphs>336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icrosoft Office User</cp:lastModifiedBy>
  <cp:revision>196</cp:revision>
  <cp:lastPrinted>2020-04-01T14:52:33Z</cp:lastPrinted>
  <dcterms:created xsi:type="dcterms:W3CDTF">2020-03-25T13:05:45Z</dcterms:created>
  <dcterms:modified xsi:type="dcterms:W3CDTF">2020-10-01T08:29:28Z</dcterms:modified>
</cp:coreProperties>
</file>